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9144000" cy="6858000" type="screen4x3"/>
  <p:notesSz cx="7559675" cy="106918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0" d="100"/>
          <a:sy n="80" d="100"/>
        </p:scale>
        <p:origin x="-1493" y="-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888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888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4673880" y="160452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4673880" y="368208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888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888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34" name="Picture 33"/>
          <p:cNvPicPr/>
          <p:nvPr/>
        </p:nvPicPr>
        <p:blipFill>
          <a:blip r:embed="rId2"/>
          <a:stretch/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  <p:pic>
        <p:nvPicPr>
          <p:cNvPr id="35" name="Picture 34"/>
          <p:cNvPicPr/>
          <p:nvPr/>
        </p:nvPicPr>
        <p:blipFill>
          <a:blip r:embed="rId2"/>
          <a:stretch/>
        </p:blipFill>
        <p:spPr>
          <a:xfrm>
            <a:off x="2079360" y="1604160"/>
            <a:ext cx="4984200" cy="397692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8880" cy="397692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888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4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4673880" y="1604520"/>
            <a:ext cx="40154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1320" cy="680976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4673880" y="1604520"/>
            <a:ext cx="40154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440" cy="397692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4673880" y="160452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4673880" y="368208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4673880" y="1604520"/>
            <a:ext cx="401544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8880" cy="1896840"/>
          </a:xfrm>
          <a:prstGeom prst="rect">
            <a:avLst/>
          </a:prstGeom>
        </p:spPr>
        <p:txBody>
          <a:bodyPr lIns="0" tIns="0" rIns="0" bIns="0"/>
          <a:lstStyle/>
          <a:p>
            <a:endParaRPr lang="en-IN" sz="32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1320" cy="14688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en-IN" sz="4400" b="0" strike="noStrike" spc="-1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8880" cy="3976920"/>
          </a:xfrm>
          <a:prstGeom prst="rect">
            <a:avLst/>
          </a:prstGeom>
        </p:spPr>
        <p:txBody>
          <a:bodyPr lIns="0" tIns="0" rIns="0" bIns="0"/>
          <a:lstStyle/>
          <a:p>
            <a:pPr marL="432000" indent="-324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Click to edit the outline text format</a:t>
            </a:r>
          </a:p>
          <a:p>
            <a:pPr marL="864000" lvl="1" indent="-324000"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Second Outline Level</a:t>
            </a:r>
          </a:p>
          <a:p>
            <a:pPr marL="1296000" lvl="2" indent="-288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Third Outline Level</a:t>
            </a:r>
          </a:p>
          <a:p>
            <a:pPr marL="1728000" lvl="3" indent="-216000"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Fourth Outline Level</a:t>
            </a:r>
          </a:p>
          <a:p>
            <a:pPr marL="2160000" lvl="4" indent="-216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Fifth Outline Level</a:t>
            </a:r>
          </a:p>
          <a:p>
            <a:pPr marL="2592000" lvl="5" indent="-216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Sixth Outline Level</a:t>
            </a:r>
          </a:p>
          <a:p>
            <a:pPr marL="3024000" lvl="6" indent="-216000"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en-IN" sz="1800" b="0" strike="noStrike" spc="-1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/>
    <p:bodyStyle/>
    <p:otherStyle/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CustomShape 1"/>
          <p:cNvSpPr/>
          <p:nvPr/>
        </p:nvSpPr>
        <p:spPr>
          <a:xfrm>
            <a:off x="1284120" y="5585768"/>
            <a:ext cx="6814440" cy="1155600"/>
          </a:xfrm>
          <a:prstGeom prst="rect">
            <a:avLst/>
          </a:prstGeom>
          <a:noFill/>
          <a:ln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/>
          <a:lstStyle/>
          <a:p>
            <a:pPr>
              <a:lnSpc>
                <a:spcPct val="100000"/>
              </a:lnSpc>
            </a:pPr>
            <a:r>
              <a:rPr lang="en-IN" sz="1000" b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Figure S4  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Density plots for crossovers, non-crossovers and crossovers plus </a:t>
            </a:r>
            <a:r>
              <a:rPr lang="en-IN" sz="1000" b="0" strike="noStrike" spc="-1" dirty="0" smtClean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non-crossovers as 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a function of chromosome size in wild type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and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.</a:t>
            </a:r>
            <a:r>
              <a:rPr lang="en-IN" sz="1000" b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 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No significant correlation (r) is seen for crossover, non-crossover and crossover plus non-crossover densities with chromosome size for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and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.  (A) Crossover density plot for wild type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 for all chromosomes excluding I, III and VI. (B) Non-crossover density plot for wild type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for all chromosomes.  (C) Crossover plus non-crossover density plot for wild type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for all chromosomes.  (D) Crossover plus non-crossover density plot for wild type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, 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mlh3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pch2</a:t>
            </a:r>
            <a:r>
              <a:rPr lang="en-IN" sz="1000" b="0" i="1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Symbol"/>
                <a:ea typeface="DejaVu Sans"/>
              </a:rPr>
              <a:t></a:t>
            </a:r>
            <a:r>
              <a:rPr lang="en-IN" sz="1000" b="0" strike="noStrike" spc="-1" dirty="0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Arial"/>
                <a:ea typeface="DejaVu Sans"/>
              </a:rPr>
              <a:t> for all chromosomes excluding I, III and VI.</a:t>
            </a:r>
            <a:endParaRPr lang="en-IN" sz="1800" b="0" strike="noStrike" spc="-1" dirty="0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pic>
        <p:nvPicPr>
          <p:cNvPr id="37" name="Picture 36"/>
          <p:cNvPicPr/>
          <p:nvPr/>
        </p:nvPicPr>
        <p:blipFill>
          <a:blip r:embed="rId2"/>
          <a:stretch/>
        </p:blipFill>
        <p:spPr>
          <a:xfrm>
            <a:off x="1333440" y="347055"/>
            <a:ext cx="6190200" cy="5095440"/>
          </a:xfrm>
          <a:prstGeom prst="rect">
            <a:avLst/>
          </a:prstGeom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>
          <p:childTnLst>
            <p:seq>
              <p:cTn id="2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174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jith V P</dc:creator>
  <dc:description/>
  <cp:lastModifiedBy>IISRTVM</cp:lastModifiedBy>
  <cp:revision>7</cp:revision>
  <dcterms:created xsi:type="dcterms:W3CDTF">2017-03-07T07:25:33Z</dcterms:created>
  <dcterms:modified xsi:type="dcterms:W3CDTF">2017-03-10T09:44:48Z</dcterms:modified>
  <dc:language>en-IN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4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On-screen Show (4:3)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